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9" r:id="rId3"/>
    <p:sldId id="260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6" d="100"/>
          <a:sy n="46" d="100"/>
        </p:scale>
        <p:origin x="33" y="3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DA910-6122-4B1F-B247-8452B3AA85F3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DF15-6994-41ED-A58B-8DC855EC04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2850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DA910-6122-4B1F-B247-8452B3AA85F3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DF15-6994-41ED-A58B-8DC855EC04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937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DA910-6122-4B1F-B247-8452B3AA85F3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DF15-6994-41ED-A58B-8DC855EC04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6934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DA910-6122-4B1F-B247-8452B3AA85F3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DF15-6994-41ED-A58B-8DC855EC04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2495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DA910-6122-4B1F-B247-8452B3AA85F3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DF15-6994-41ED-A58B-8DC855EC04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46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DA910-6122-4B1F-B247-8452B3AA85F3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DF15-6994-41ED-A58B-8DC855EC04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2577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DA910-6122-4B1F-B247-8452B3AA85F3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DF15-6994-41ED-A58B-8DC855EC04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7654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DA910-6122-4B1F-B247-8452B3AA85F3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DF15-6994-41ED-A58B-8DC855EC04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06884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DA910-6122-4B1F-B247-8452B3AA85F3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DF15-6994-41ED-A58B-8DC855EC04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1951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DA910-6122-4B1F-B247-8452B3AA85F3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DF15-6994-41ED-A58B-8DC855EC04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9648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DA910-6122-4B1F-B247-8452B3AA85F3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DF15-6994-41ED-A58B-8DC855EC04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25043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ADA910-6122-4B1F-B247-8452B3AA85F3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FDDF15-6994-41ED-A58B-8DC855EC04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5586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60C68FE4-B8D3-4869-A736-F4DFA82158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4247" y="3465411"/>
            <a:ext cx="5155126" cy="99737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199036C0-DBB8-4439-BA0C-30C700FD67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4246" y="4595237"/>
            <a:ext cx="5155127" cy="933989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BE02991-F23E-4D55-AC8D-97B5BB44241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5702" y="5629806"/>
            <a:ext cx="5046248" cy="1105017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60750CD9-E66E-404B-95F0-4B6F13D652F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58108" y="602999"/>
            <a:ext cx="4831405" cy="1708001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E2A841B6-1F0F-4392-8C3A-028051C6A46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05702" y="2134271"/>
            <a:ext cx="5046248" cy="1132941"/>
          </a:xfrm>
          <a:prstGeom prst="rect">
            <a:avLst/>
          </a:prstGeom>
        </p:spPr>
      </p:pic>
      <p:grpSp>
        <p:nvGrpSpPr>
          <p:cNvPr id="8" name="组合 7">
            <a:extLst>
              <a:ext uri="{FF2B5EF4-FFF2-40B4-BE49-F238E27FC236}">
                <a16:creationId xmlns:a16="http://schemas.microsoft.com/office/drawing/2014/main" id="{1AE0534D-4A0F-44DC-8A71-8DD7AEC9EB9C}"/>
              </a:ext>
            </a:extLst>
          </p:cNvPr>
          <p:cNvGrpSpPr/>
          <p:nvPr/>
        </p:nvGrpSpPr>
        <p:grpSpPr>
          <a:xfrm>
            <a:off x="1339403" y="163865"/>
            <a:ext cx="4936316" cy="667378"/>
            <a:chOff x="0" y="1081000"/>
            <a:chExt cx="4936316" cy="667378"/>
          </a:xfrm>
        </p:grpSpPr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34BEF18C-126A-432B-9F31-802987087C76}"/>
                </a:ext>
              </a:extLst>
            </p:cNvPr>
            <p:cNvSpPr txBox="1"/>
            <p:nvPr/>
          </p:nvSpPr>
          <p:spPr>
            <a:xfrm>
              <a:off x="0" y="1403385"/>
              <a:ext cx="113789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/>
                <a:t>Erastin</a:t>
              </a:r>
              <a:r>
                <a:rPr lang="en-US" altLang="zh-CN" sz="1600" dirty="0"/>
                <a:t>(</a:t>
              </a:r>
              <a:r>
                <a:rPr lang="el-GR" altLang="zh-CN" sz="1600" dirty="0"/>
                <a:t>μ</a:t>
              </a:r>
              <a:r>
                <a:rPr lang="en-US" altLang="zh-CN" sz="1600" dirty="0"/>
                <a:t>M)</a:t>
              </a:r>
              <a:endParaRPr lang="zh-CN" altLang="en-US" sz="1600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91571AD2-8A36-4213-9114-830F1BDBD2CB}"/>
                </a:ext>
              </a:extLst>
            </p:cNvPr>
            <p:cNvSpPr txBox="1"/>
            <p:nvPr/>
          </p:nvSpPr>
          <p:spPr>
            <a:xfrm>
              <a:off x="3658654" y="1089763"/>
              <a:ext cx="8500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MCF-7</a:t>
              </a:r>
              <a:endParaRPr lang="zh-CN" altLang="en-US" sz="1600" dirty="0"/>
            </a:p>
          </p:txBody>
        </p: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933DAC1D-0BE4-4012-9E31-F7F5B978ECF0}"/>
                </a:ext>
              </a:extLst>
            </p:cNvPr>
            <p:cNvCxnSpPr>
              <a:cxnSpLocks/>
              <a:endCxn id="19" idx="0"/>
            </p:cNvCxnSpPr>
            <p:nvPr/>
          </p:nvCxnSpPr>
          <p:spPr>
            <a:xfrm>
              <a:off x="3122309" y="1388342"/>
              <a:ext cx="1597905" cy="1691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38E47E8E-911A-4A66-8096-D99F9B827B56}"/>
                </a:ext>
              </a:extLst>
            </p:cNvPr>
            <p:cNvSpPr txBox="1"/>
            <p:nvPr/>
          </p:nvSpPr>
          <p:spPr>
            <a:xfrm>
              <a:off x="3104735" y="1405257"/>
              <a:ext cx="32398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0</a:t>
              </a:r>
              <a:endParaRPr lang="zh-CN" altLang="en-US" sz="1600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805EF816-5F8B-40F9-8B53-E7E129BFD10D}"/>
                </a:ext>
              </a:extLst>
            </p:cNvPr>
            <p:cNvSpPr txBox="1"/>
            <p:nvPr/>
          </p:nvSpPr>
          <p:spPr>
            <a:xfrm>
              <a:off x="3499048" y="1409824"/>
              <a:ext cx="4322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10</a:t>
              </a:r>
              <a:endParaRPr lang="zh-CN" altLang="en-US" sz="1600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2C3A665B-D61E-4A11-B3CD-7821E0E671FC}"/>
                </a:ext>
              </a:extLst>
            </p:cNvPr>
            <p:cNvSpPr txBox="1"/>
            <p:nvPr/>
          </p:nvSpPr>
          <p:spPr>
            <a:xfrm>
              <a:off x="4001579" y="1402561"/>
              <a:ext cx="4322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20</a:t>
              </a:r>
              <a:endParaRPr lang="zh-CN" altLang="en-US" sz="1600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974DD823-02F8-48C1-974D-61BDDBCE33C7}"/>
                </a:ext>
              </a:extLst>
            </p:cNvPr>
            <p:cNvSpPr txBox="1"/>
            <p:nvPr/>
          </p:nvSpPr>
          <p:spPr>
            <a:xfrm>
              <a:off x="4504112" y="1405257"/>
              <a:ext cx="4322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40</a:t>
              </a:r>
              <a:endParaRPr lang="zh-CN" altLang="en-US" sz="1600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3487F15F-EE84-4658-BF0C-9DCAD331A782}"/>
                </a:ext>
              </a:extLst>
            </p:cNvPr>
            <p:cNvSpPr txBox="1"/>
            <p:nvPr/>
          </p:nvSpPr>
          <p:spPr>
            <a:xfrm>
              <a:off x="1344499" y="1081000"/>
              <a:ext cx="146255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MDA-MB-231</a:t>
              </a:r>
              <a:endParaRPr lang="zh-CN" altLang="en-US" sz="1600" dirty="0"/>
            </a:p>
          </p:txBody>
        </p: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B220CA3A-8F38-4351-A705-CD2870CA113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7334" y="1400689"/>
              <a:ext cx="1776206" cy="4568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ED9F8810-8194-4BEE-8211-55276EAB2116}"/>
                </a:ext>
              </a:extLst>
            </p:cNvPr>
            <p:cNvSpPr txBox="1"/>
            <p:nvPr/>
          </p:nvSpPr>
          <p:spPr>
            <a:xfrm>
              <a:off x="1052049" y="1407128"/>
              <a:ext cx="3630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0</a:t>
              </a:r>
              <a:endParaRPr lang="zh-CN" altLang="en-US" sz="1600" dirty="0"/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DEC979FE-E944-4787-8247-4260770AFFAF}"/>
                </a:ext>
              </a:extLst>
            </p:cNvPr>
            <p:cNvSpPr txBox="1"/>
            <p:nvPr/>
          </p:nvSpPr>
          <p:spPr>
            <a:xfrm>
              <a:off x="1485386" y="1407128"/>
              <a:ext cx="5171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10</a:t>
              </a:r>
              <a:endParaRPr lang="zh-CN" altLang="en-US" sz="1600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A7205AB0-C10D-41D8-A798-172CB56B6E8B}"/>
                </a:ext>
              </a:extLst>
            </p:cNvPr>
            <p:cNvSpPr txBox="1"/>
            <p:nvPr/>
          </p:nvSpPr>
          <p:spPr>
            <a:xfrm>
              <a:off x="2072824" y="1407128"/>
              <a:ext cx="4524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20</a:t>
              </a:r>
              <a:endParaRPr lang="zh-CN" altLang="en-US" sz="1600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3CA47984-4075-4B30-9DA3-FA797F122B8A}"/>
                </a:ext>
              </a:extLst>
            </p:cNvPr>
            <p:cNvSpPr txBox="1"/>
            <p:nvPr/>
          </p:nvSpPr>
          <p:spPr>
            <a:xfrm>
              <a:off x="2595603" y="1403449"/>
              <a:ext cx="4388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40</a:t>
              </a:r>
              <a:endParaRPr lang="zh-CN" altLang="en-US" sz="1600" dirty="0"/>
            </a:p>
          </p:txBody>
        </p:sp>
      </p:grpSp>
      <p:sp>
        <p:nvSpPr>
          <p:cNvPr id="26" name="文本框 25">
            <a:extLst>
              <a:ext uri="{FF2B5EF4-FFF2-40B4-BE49-F238E27FC236}">
                <a16:creationId xmlns:a16="http://schemas.microsoft.com/office/drawing/2014/main" id="{CB814796-E70E-4651-A8AB-93BA842412F7}"/>
              </a:ext>
            </a:extLst>
          </p:cNvPr>
          <p:cNvSpPr txBox="1"/>
          <p:nvPr/>
        </p:nvSpPr>
        <p:spPr>
          <a:xfrm>
            <a:off x="984451" y="1328774"/>
            <a:ext cx="9197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G6PD-H</a:t>
            </a:r>
            <a:endParaRPr lang="zh-CN" altLang="en-US" sz="16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6D9D8CF-BB01-4565-AE0E-58BAE5037A16}"/>
              </a:ext>
            </a:extLst>
          </p:cNvPr>
          <p:cNvSpPr txBox="1"/>
          <p:nvPr/>
        </p:nvSpPr>
        <p:spPr>
          <a:xfrm>
            <a:off x="984451" y="2467489"/>
            <a:ext cx="8205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G6PD-L</a:t>
            </a:r>
            <a:endParaRPr lang="zh-CN" altLang="en-US" sz="16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BA18D2A-5774-464D-B00B-F5527507B78A}"/>
              </a:ext>
            </a:extLst>
          </p:cNvPr>
          <p:cNvSpPr txBox="1"/>
          <p:nvPr/>
        </p:nvSpPr>
        <p:spPr>
          <a:xfrm>
            <a:off x="969701" y="3794823"/>
            <a:ext cx="8500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PIK3CA</a:t>
            </a:r>
            <a:endParaRPr lang="zh-CN" altLang="en-US" sz="16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BE3DD13B-C39F-46BE-ADFF-EC6A9A965B76}"/>
              </a:ext>
            </a:extLst>
          </p:cNvPr>
          <p:cNvSpPr txBox="1"/>
          <p:nvPr/>
        </p:nvSpPr>
        <p:spPr>
          <a:xfrm>
            <a:off x="1083741" y="4892954"/>
            <a:ext cx="7212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BRD4</a:t>
            </a:r>
            <a:endParaRPr lang="zh-CN" altLang="en-US" sz="16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30E3E5EC-7646-4574-8E86-DF5C5236BA4E}"/>
              </a:ext>
            </a:extLst>
          </p:cNvPr>
          <p:cNvSpPr txBox="1"/>
          <p:nvPr/>
        </p:nvSpPr>
        <p:spPr>
          <a:xfrm>
            <a:off x="934947" y="5922318"/>
            <a:ext cx="9195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GAPDH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33028603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F441A1E2-F600-4DA7-9CBC-5EF4ECF2FCA1}"/>
              </a:ext>
            </a:extLst>
          </p:cNvPr>
          <p:cNvSpPr txBox="1"/>
          <p:nvPr/>
        </p:nvSpPr>
        <p:spPr>
          <a:xfrm>
            <a:off x="1366830" y="600093"/>
            <a:ext cx="14625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MDA-MB-231</a:t>
            </a:r>
            <a:endParaRPr lang="zh-CN" altLang="en-US" sz="1600" dirty="0"/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871E3641-CF53-46E5-87C8-9BE4A87570BB}"/>
              </a:ext>
            </a:extLst>
          </p:cNvPr>
          <p:cNvCxnSpPr/>
          <p:nvPr/>
        </p:nvCxnSpPr>
        <p:spPr>
          <a:xfrm>
            <a:off x="1375219" y="905091"/>
            <a:ext cx="128409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5F3D9769-1169-48E0-BA81-8C0FBAC6841D}"/>
              </a:ext>
            </a:extLst>
          </p:cNvPr>
          <p:cNvSpPr txBox="1"/>
          <p:nvPr/>
        </p:nvSpPr>
        <p:spPr>
          <a:xfrm>
            <a:off x="1443567" y="938647"/>
            <a:ext cx="5733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45F4B53-2641-4F82-BC4F-4A0C9A164252}"/>
              </a:ext>
            </a:extLst>
          </p:cNvPr>
          <p:cNvSpPr txBox="1"/>
          <p:nvPr/>
        </p:nvSpPr>
        <p:spPr>
          <a:xfrm>
            <a:off x="2093625" y="938647"/>
            <a:ext cx="5733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OE</a:t>
            </a:r>
            <a:endParaRPr lang="zh-CN" altLang="en-US" sz="1600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50059CA-390A-4ACC-88B2-65691B9F0A98}"/>
              </a:ext>
            </a:extLst>
          </p:cNvPr>
          <p:cNvSpPr txBox="1"/>
          <p:nvPr/>
        </p:nvSpPr>
        <p:spPr>
          <a:xfrm>
            <a:off x="718308" y="2455492"/>
            <a:ext cx="7172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G6PD</a:t>
            </a:r>
            <a:endParaRPr lang="zh-CN" altLang="en-US" sz="16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7F50DF7-429D-4A09-AF3C-170183323D9A}"/>
              </a:ext>
            </a:extLst>
          </p:cNvPr>
          <p:cNvSpPr txBox="1"/>
          <p:nvPr/>
        </p:nvSpPr>
        <p:spPr>
          <a:xfrm>
            <a:off x="746261" y="3972336"/>
            <a:ext cx="9179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GAPDH</a:t>
            </a:r>
            <a:endParaRPr lang="zh-CN" altLang="en-US" sz="1600" dirty="0"/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06494859-3D25-4FAD-8E76-B0C1BAEACB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3031" y="3613745"/>
            <a:ext cx="2119237" cy="1650561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5FB40682-E195-441F-9BF0-D8EF505444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83031" y="1477641"/>
            <a:ext cx="2712132" cy="21361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91928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01F2907-3C46-4EF4-A8D4-93107DE7A6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5077" y="364072"/>
            <a:ext cx="2205426" cy="1756357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5C359246-9968-4943-B1CF-0C4270E500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65996" y="231392"/>
            <a:ext cx="2246498" cy="1886562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5933409-EE09-4410-84D4-40466DFD7E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94262" y="231392"/>
            <a:ext cx="2123008" cy="197659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84B957E6-831D-48A2-96AF-0FFC3F6195F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0607" y="2268736"/>
            <a:ext cx="2475580" cy="1607851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D52F43C6-47CB-4A77-A4F4-03B9DFF59AB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25294" y="2207985"/>
            <a:ext cx="2614603" cy="1702533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B96607F0-C2B7-44F4-96E0-E23C78AC445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70963" y="2069113"/>
            <a:ext cx="2472927" cy="1886562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F1B1F3C2-37EE-4FFF-A422-53C700C122F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09796" y="3898389"/>
            <a:ext cx="2822173" cy="1607852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79F5AECF-FCCA-46F5-AB73-B26204E896A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9646" y="3885471"/>
            <a:ext cx="3165648" cy="1702533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5ABB1498-0BFF-4451-931D-3585961AD08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980622" y="3876587"/>
            <a:ext cx="2797016" cy="1702532"/>
          </a:xfrm>
          <a:prstGeom prst="rect">
            <a:avLst/>
          </a:prstGeom>
        </p:spPr>
      </p:pic>
      <p:grpSp>
        <p:nvGrpSpPr>
          <p:cNvPr id="12" name="组合 11">
            <a:extLst>
              <a:ext uri="{FF2B5EF4-FFF2-40B4-BE49-F238E27FC236}">
                <a16:creationId xmlns:a16="http://schemas.microsoft.com/office/drawing/2014/main" id="{D505A11C-5C41-4F42-9918-CB26C9264E38}"/>
              </a:ext>
            </a:extLst>
          </p:cNvPr>
          <p:cNvGrpSpPr/>
          <p:nvPr/>
        </p:nvGrpSpPr>
        <p:grpSpPr>
          <a:xfrm>
            <a:off x="0" y="-21399"/>
            <a:ext cx="5417270" cy="667378"/>
            <a:chOff x="0" y="1081000"/>
            <a:chExt cx="4936316" cy="667378"/>
          </a:xfrm>
        </p:grpSpPr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173B7C70-FDC9-438E-9EC7-C8CC3DA5B715}"/>
                </a:ext>
              </a:extLst>
            </p:cNvPr>
            <p:cNvSpPr txBox="1"/>
            <p:nvPr/>
          </p:nvSpPr>
          <p:spPr>
            <a:xfrm>
              <a:off x="0" y="1403385"/>
              <a:ext cx="113789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/>
                <a:t>Erastin</a:t>
              </a:r>
              <a:r>
                <a:rPr lang="en-US" altLang="zh-CN" sz="1600" dirty="0"/>
                <a:t>(</a:t>
              </a:r>
              <a:r>
                <a:rPr lang="el-GR" altLang="zh-CN" sz="1600" dirty="0"/>
                <a:t>μ</a:t>
              </a:r>
              <a:r>
                <a:rPr lang="en-US" altLang="zh-CN" sz="1600" dirty="0"/>
                <a:t>M)</a:t>
              </a:r>
              <a:endParaRPr lang="zh-CN" altLang="en-US" sz="1600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0BE9536C-9620-4DF9-A42E-932517AA96E6}"/>
                </a:ext>
              </a:extLst>
            </p:cNvPr>
            <p:cNvSpPr txBox="1"/>
            <p:nvPr/>
          </p:nvSpPr>
          <p:spPr>
            <a:xfrm>
              <a:off x="3658654" y="1089763"/>
              <a:ext cx="8500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BT-549</a:t>
              </a:r>
              <a:endParaRPr lang="zh-CN" altLang="en-US" sz="1600" dirty="0"/>
            </a:p>
          </p:txBody>
        </p: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EE8D1954-416A-413A-8D51-FD9C9526E3E6}"/>
                </a:ext>
              </a:extLst>
            </p:cNvPr>
            <p:cNvCxnSpPr>
              <a:cxnSpLocks/>
              <a:endCxn id="24" idx="0"/>
            </p:cNvCxnSpPr>
            <p:nvPr/>
          </p:nvCxnSpPr>
          <p:spPr>
            <a:xfrm>
              <a:off x="3122309" y="1388342"/>
              <a:ext cx="1597905" cy="1691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56C54AE3-4886-4275-9BE3-9CCA5413C30C}"/>
                </a:ext>
              </a:extLst>
            </p:cNvPr>
            <p:cNvSpPr txBox="1"/>
            <p:nvPr/>
          </p:nvSpPr>
          <p:spPr>
            <a:xfrm>
              <a:off x="3104735" y="1405257"/>
              <a:ext cx="32398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0</a:t>
              </a:r>
              <a:endParaRPr lang="zh-CN" altLang="en-US" sz="1600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E6091B79-70C7-4885-9184-F3B4DFDFBDD5}"/>
                </a:ext>
              </a:extLst>
            </p:cNvPr>
            <p:cNvSpPr txBox="1"/>
            <p:nvPr/>
          </p:nvSpPr>
          <p:spPr>
            <a:xfrm>
              <a:off x="3499048" y="1409824"/>
              <a:ext cx="4322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10</a:t>
              </a:r>
              <a:endParaRPr lang="zh-CN" altLang="en-US" sz="1600" dirty="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5847E5DD-ABD8-4C2E-8339-40A16DD50F47}"/>
                </a:ext>
              </a:extLst>
            </p:cNvPr>
            <p:cNvSpPr txBox="1"/>
            <p:nvPr/>
          </p:nvSpPr>
          <p:spPr>
            <a:xfrm>
              <a:off x="4001579" y="1402561"/>
              <a:ext cx="4322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20</a:t>
              </a:r>
              <a:endParaRPr lang="zh-CN" altLang="en-US" sz="1600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C17AB3B6-F96F-4B22-BF0A-92B92169A9A1}"/>
                </a:ext>
              </a:extLst>
            </p:cNvPr>
            <p:cNvSpPr txBox="1"/>
            <p:nvPr/>
          </p:nvSpPr>
          <p:spPr>
            <a:xfrm>
              <a:off x="4504112" y="1405257"/>
              <a:ext cx="4322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40</a:t>
              </a:r>
              <a:endParaRPr lang="zh-CN" altLang="en-US" sz="1600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194E9C90-24BC-42F3-B920-ECB30454F681}"/>
                </a:ext>
              </a:extLst>
            </p:cNvPr>
            <p:cNvSpPr txBox="1"/>
            <p:nvPr/>
          </p:nvSpPr>
          <p:spPr>
            <a:xfrm>
              <a:off x="1344499" y="1081000"/>
              <a:ext cx="146255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MCF-10A</a:t>
              </a:r>
              <a:endParaRPr lang="zh-CN" altLang="en-US" sz="1600" dirty="0"/>
            </a:p>
          </p:txBody>
        </p: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8F067616-B357-4D07-BF96-A528BE5F242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7334" y="1400689"/>
              <a:ext cx="1776206" cy="4568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A9963A44-4D92-4B0D-B665-242CD6DED4B7}"/>
                </a:ext>
              </a:extLst>
            </p:cNvPr>
            <p:cNvSpPr txBox="1"/>
            <p:nvPr/>
          </p:nvSpPr>
          <p:spPr>
            <a:xfrm>
              <a:off x="1052049" y="1407128"/>
              <a:ext cx="3630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0</a:t>
              </a:r>
              <a:endParaRPr lang="zh-CN" altLang="en-US" sz="1600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7E1B639C-D0AC-4EAA-AA83-4EE66A37B1DA}"/>
                </a:ext>
              </a:extLst>
            </p:cNvPr>
            <p:cNvSpPr txBox="1"/>
            <p:nvPr/>
          </p:nvSpPr>
          <p:spPr>
            <a:xfrm>
              <a:off x="1485386" y="1407128"/>
              <a:ext cx="5171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10</a:t>
              </a:r>
              <a:endParaRPr lang="zh-CN" altLang="en-US" sz="1600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864D40BA-D1D5-4FA0-9345-5DB23C2FE8DD}"/>
                </a:ext>
              </a:extLst>
            </p:cNvPr>
            <p:cNvSpPr txBox="1"/>
            <p:nvPr/>
          </p:nvSpPr>
          <p:spPr>
            <a:xfrm>
              <a:off x="2072824" y="1407128"/>
              <a:ext cx="4524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20</a:t>
              </a:r>
              <a:endParaRPr lang="zh-CN" altLang="en-US" sz="1600" dirty="0"/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38262FFD-9C5D-4B90-B552-D574ED57E763}"/>
                </a:ext>
              </a:extLst>
            </p:cNvPr>
            <p:cNvSpPr txBox="1"/>
            <p:nvPr/>
          </p:nvSpPr>
          <p:spPr>
            <a:xfrm>
              <a:off x="2595603" y="1403449"/>
              <a:ext cx="4388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40</a:t>
              </a:r>
              <a:endParaRPr lang="zh-CN" altLang="en-US" sz="1600" dirty="0"/>
            </a:p>
          </p:txBody>
        </p:sp>
      </p:grp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3DA7EC89-14E2-48DA-BAE0-296248ACA2E4}"/>
              </a:ext>
            </a:extLst>
          </p:cNvPr>
          <p:cNvCxnSpPr>
            <a:cxnSpLocks/>
            <a:endCxn id="36" idx="0"/>
          </p:cNvCxnSpPr>
          <p:nvPr/>
        </p:nvCxnSpPr>
        <p:spPr>
          <a:xfrm>
            <a:off x="5795132" y="283247"/>
            <a:ext cx="1753592" cy="1691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53AA430A-870A-442D-A057-A6DBC4C36BAE}"/>
              </a:ext>
            </a:extLst>
          </p:cNvPr>
          <p:cNvSpPr txBox="1"/>
          <p:nvPr/>
        </p:nvSpPr>
        <p:spPr>
          <a:xfrm>
            <a:off x="5775846" y="300162"/>
            <a:ext cx="3555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0</a:t>
            </a:r>
            <a:endParaRPr lang="zh-CN" altLang="en-US" sz="16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9FD5F81-61C3-4330-AED1-D0BA33BF1F62}"/>
              </a:ext>
            </a:extLst>
          </p:cNvPr>
          <p:cNvSpPr txBox="1"/>
          <p:nvPr/>
        </p:nvSpPr>
        <p:spPr>
          <a:xfrm>
            <a:off x="6208577" y="304729"/>
            <a:ext cx="4743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10</a:t>
            </a:r>
            <a:endParaRPr lang="zh-CN" altLang="en-US" sz="16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DAE118A-8559-4438-A477-D48C22661E89}"/>
              </a:ext>
            </a:extLst>
          </p:cNvPr>
          <p:cNvSpPr txBox="1"/>
          <p:nvPr/>
        </p:nvSpPr>
        <p:spPr>
          <a:xfrm>
            <a:off x="6760071" y="297466"/>
            <a:ext cx="4743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20</a:t>
            </a:r>
            <a:endParaRPr lang="zh-CN" altLang="en-US" sz="16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A5BFFCF-0249-40FF-846B-02FB0579E8B4}"/>
              </a:ext>
            </a:extLst>
          </p:cNvPr>
          <p:cNvSpPr txBox="1"/>
          <p:nvPr/>
        </p:nvSpPr>
        <p:spPr>
          <a:xfrm>
            <a:off x="7311567" y="300162"/>
            <a:ext cx="4743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40</a:t>
            </a:r>
            <a:endParaRPr lang="zh-CN" altLang="en-US" sz="1600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9F79BCA5-7A11-4CF4-B835-4213D541527C}"/>
              </a:ext>
            </a:extLst>
          </p:cNvPr>
          <p:cNvSpPr txBox="1"/>
          <p:nvPr/>
        </p:nvSpPr>
        <p:spPr>
          <a:xfrm>
            <a:off x="6202263" y="0"/>
            <a:ext cx="1100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SUM-159</a:t>
            </a:r>
            <a:endParaRPr lang="zh-CN" altLang="en-US" sz="1600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2FFACC7-9FC2-4A78-AFB4-BACDA38A0A0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08039" y="5366296"/>
            <a:ext cx="2644141" cy="146742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8CC28C63-D85A-4AC5-B8EF-32806898C4C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202722" y="5477091"/>
            <a:ext cx="2568676" cy="1284338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7EA3A30-D4AE-4F63-A8CA-4366C9D0E1B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005273" y="5484039"/>
            <a:ext cx="2797015" cy="14453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63298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5</TotalTime>
  <Words>45</Words>
  <Application>Microsoft Office PowerPoint</Application>
  <PresentationFormat>全屏显示(4:3)</PresentationFormat>
  <Paragraphs>37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朱 丽喆</dc:creator>
  <cp:lastModifiedBy>朱 丽喆</cp:lastModifiedBy>
  <cp:revision>13</cp:revision>
  <dcterms:created xsi:type="dcterms:W3CDTF">2021-04-28T12:29:30Z</dcterms:created>
  <dcterms:modified xsi:type="dcterms:W3CDTF">2021-05-10T12:52:59Z</dcterms:modified>
</cp:coreProperties>
</file>